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648450" cy="97742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D7528-7744-4FFF-97C6-781158CDEE5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22FA2-2E86-4A1C-9530-D4DD933ACA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F0615A-E458-44C1-A8C2-86F8E4611D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1F4BD-3684-446E-9E2D-CA09ED4258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6F0F2-287F-4CCC-8407-E449868310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D77D25-F821-4012-9487-A7445059A4B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BAF430-57A8-4B42-A1AD-7ACA02471B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69543F-C041-465C-AC4F-736C95D88B8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CDF60-3030-4F4E-906A-8F752EB9D7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42D62B-25E1-405E-9CD1-1A18E112D7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E0D7BE-9D6F-4E1C-9FC6-CDA69254B2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425B0-72D1-45A4-BEBC-B06CD6821A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E9BDFA0-97BD-4F85-9A72-91E5BA0D5798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1511280" y="549360"/>
            <a:ext cx="3025800" cy="2119320"/>
          </a:xfrm>
          <a:prstGeom prst="rect">
            <a:avLst/>
          </a:prstGeom>
          <a:ln w="0">
            <a:noFill/>
          </a:ln>
        </p:spPr>
      </p:pic>
      <p:sp>
        <p:nvSpPr>
          <p:cNvPr id="42" name="Textfeld 3"/>
          <p:cNvSpPr/>
          <p:nvPr/>
        </p:nvSpPr>
        <p:spPr>
          <a:xfrm>
            <a:off x="782640" y="5877000"/>
            <a:ext cx="266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 S1.</a:t>
            </a:r>
            <a:r>
              <a:rPr b="0" lang="de-DE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Valera 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Gruppieren 4"/>
          <p:cNvGrpSpPr/>
          <p:nvPr/>
        </p:nvGrpSpPr>
        <p:grpSpPr>
          <a:xfrm>
            <a:off x="1511280" y="3191040"/>
            <a:ext cx="6732720" cy="2362320"/>
            <a:chOff x="1511280" y="3191040"/>
            <a:chExt cx="6732720" cy="2362320"/>
          </a:xfrm>
        </p:grpSpPr>
        <p:pic>
          <p:nvPicPr>
            <p:cNvPr id="44" name="Grafik 5" descr=""/>
            <p:cNvPicPr/>
            <p:nvPr/>
          </p:nvPicPr>
          <p:blipFill>
            <a:blip r:embed="rId2"/>
            <a:stretch/>
          </p:blipFill>
          <p:spPr>
            <a:xfrm>
              <a:off x="2880360" y="3979440"/>
              <a:ext cx="5363640" cy="531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feld 6"/>
            <p:cNvSpPr/>
            <p:nvPr/>
          </p:nvSpPr>
          <p:spPr>
            <a:xfrm>
              <a:off x="4846680" y="5112720"/>
              <a:ext cx="246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KOEU_05990 predicted prephenate dehydratas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Gerade Verbindung 7"/>
            <p:cNvSpPr/>
            <p:nvPr/>
          </p:nvSpPr>
          <p:spPr>
            <a:xfrm>
              <a:off x="4896000" y="4179960"/>
              <a:ext cx="0" cy="933480"/>
            </a:xfrm>
            <a:prstGeom prst="line">
              <a:avLst/>
            </a:prstGeom>
            <a:ln w="2844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hteck 8"/>
            <p:cNvSpPr/>
            <p:nvPr/>
          </p:nvSpPr>
          <p:spPr>
            <a:xfrm>
              <a:off x="1511280" y="3519000"/>
              <a:ext cx="3189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rchaeal fructose-1,6-bisphosphatase and related enzymes of inositol monophosphatase family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Gerade Verbindung 9"/>
            <p:cNvSpPr/>
            <p:nvPr/>
          </p:nvSpPr>
          <p:spPr>
            <a:xfrm>
              <a:off x="4505400" y="3660840"/>
              <a:ext cx="0" cy="70776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hteck 10"/>
            <p:cNvSpPr/>
            <p:nvPr/>
          </p:nvSpPr>
          <p:spPr>
            <a:xfrm>
              <a:off x="4243320" y="3288240"/>
              <a:ext cx="884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ytochrome c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Gerade Verbindung 11"/>
            <p:cNvSpPr/>
            <p:nvPr/>
          </p:nvSpPr>
          <p:spPr>
            <a:xfrm>
              <a:off x="4603680" y="3519360"/>
              <a:ext cx="0" cy="82044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hteck 12"/>
            <p:cNvSpPr/>
            <p:nvPr/>
          </p:nvSpPr>
          <p:spPr>
            <a:xfrm>
              <a:off x="2544120" y="5322240"/>
              <a:ext cx="3096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-deoxy-D-manno-octulosonate cytidylyltransferas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Gerade Verbindung 13"/>
            <p:cNvSpPr/>
            <p:nvPr/>
          </p:nvSpPr>
          <p:spPr>
            <a:xfrm>
              <a:off x="4756320" y="4159440"/>
              <a:ext cx="0" cy="116496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hteck 14"/>
            <p:cNvSpPr/>
            <p:nvPr/>
          </p:nvSpPr>
          <p:spPr>
            <a:xfrm>
              <a:off x="4952880" y="4560480"/>
              <a:ext cx="1506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ihydrodipicolinate synthas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Gerade Verbindung 15"/>
            <p:cNvSpPr/>
            <p:nvPr/>
          </p:nvSpPr>
          <p:spPr>
            <a:xfrm>
              <a:off x="5041800" y="4159440"/>
              <a:ext cx="0" cy="38736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hteck 16"/>
            <p:cNvSpPr/>
            <p:nvPr/>
          </p:nvSpPr>
          <p:spPr>
            <a:xfrm>
              <a:off x="5142600" y="3191040"/>
              <a:ext cx="1155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srA-binding prote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Gerade Verbindung 17"/>
            <p:cNvSpPr/>
            <p:nvPr/>
          </p:nvSpPr>
          <p:spPr>
            <a:xfrm>
              <a:off x="5187960" y="3413160"/>
              <a:ext cx="0" cy="70776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hteck 18"/>
            <p:cNvSpPr/>
            <p:nvPr/>
          </p:nvSpPr>
          <p:spPr>
            <a:xfrm>
              <a:off x="5240160" y="3651480"/>
              <a:ext cx="1101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ld shock protein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Gerade Verbindung 19"/>
            <p:cNvSpPr/>
            <p:nvPr/>
          </p:nvSpPr>
          <p:spPr>
            <a:xfrm>
              <a:off x="5334120" y="3873600"/>
              <a:ext cx="0" cy="417240"/>
            </a:xfrm>
            <a:prstGeom prst="line">
              <a:avLst/>
            </a:prstGeom>
            <a:ln w="28440">
              <a:solidFill>
                <a:srgbClr val="4a7ebb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feld 20"/>
          <p:cNvSpPr/>
          <p:nvPr/>
        </p:nvSpPr>
        <p:spPr>
          <a:xfrm>
            <a:off x="1332000" y="404640"/>
            <a:ext cx="56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feld 22"/>
          <p:cNvSpPr/>
          <p:nvPr/>
        </p:nvSpPr>
        <p:spPr>
          <a:xfrm>
            <a:off x="1484280" y="2820960"/>
            <a:ext cx="56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Objeto 1" descr=""/>
          <p:cNvPicPr/>
          <p:nvPr/>
        </p:nvPicPr>
        <p:blipFill>
          <a:blip r:embed="rId3"/>
          <a:srcRect l="-4389" t="-2523" r="-9405" b="-269"/>
          <a:stretch/>
        </p:blipFill>
        <p:spPr>
          <a:xfrm>
            <a:off x="5781600" y="304920"/>
            <a:ext cx="1765440" cy="2606400"/>
          </a:xfrm>
          <a:prstGeom prst="rect">
            <a:avLst/>
          </a:prstGeom>
          <a:ln w="0">
            <a:noFill/>
          </a:ln>
        </p:spPr>
      </p:pic>
      <p:sp>
        <p:nvSpPr>
          <p:cNvPr id="62" name="Textfeld 23"/>
          <p:cNvSpPr/>
          <p:nvPr/>
        </p:nvSpPr>
        <p:spPr>
          <a:xfrm>
            <a:off x="5140440" y="372960"/>
            <a:ext cx="56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26T08:10:14Z</dcterms:created>
  <dc:creator>Sabine Keuter</dc:creator>
  <dc:description/>
  <dc:language>en-US</dc:language>
  <cp:lastModifiedBy>Estibaliz Mateo Alesanco</cp:lastModifiedBy>
  <cp:lastPrinted>2015-07-08T05:09:04Z</cp:lastPrinted>
  <dcterms:modified xsi:type="dcterms:W3CDTF">2015-11-30T13:18:23Z</dcterms:modified>
  <cp:revision>102</cp:revision>
  <dc:subject/>
  <dc:title>PowerPoint-Präsentation</dc:title>
</cp:coreProperties>
</file>